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0" r:id="rId5"/>
    <p:sldId id="261" r:id="rId6"/>
    <p:sldId id="269" r:id="rId7"/>
  </p:sldIdLst>
  <p:sldSz cx="12192000" cy="6858000"/>
  <p:notesSz cx="6954838" cy="92408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-126" y="-1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3C411-4DBC-4709-8476-A4BCA249FD7D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2402E-BE04-48F4-9292-9007BD76C8A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318954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3C411-4DBC-4709-8476-A4BCA249FD7D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2402E-BE04-48F4-9292-9007BD76C8A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242060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3C411-4DBC-4709-8476-A4BCA249FD7D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2402E-BE04-48F4-9292-9007BD76C8A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4876252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3C411-4DBC-4709-8476-A4BCA249FD7D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2402E-BE04-48F4-9292-9007BD76C8A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8219472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3C411-4DBC-4709-8476-A4BCA249FD7D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2402E-BE04-48F4-9292-9007BD76C8A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5419778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3C411-4DBC-4709-8476-A4BCA249FD7D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2402E-BE04-48F4-9292-9007BD76C8A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825015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3C411-4DBC-4709-8476-A4BCA249FD7D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2402E-BE04-48F4-9292-9007BD76C8A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039308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3C411-4DBC-4709-8476-A4BCA249FD7D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2402E-BE04-48F4-9292-9007BD76C8A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9966506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3C411-4DBC-4709-8476-A4BCA249FD7D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2402E-BE04-48F4-9292-9007BD76C8A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797402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3C411-4DBC-4709-8476-A4BCA249FD7D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2402E-BE04-48F4-9292-9007BD76C8A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982449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3C411-4DBC-4709-8476-A4BCA249FD7D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2402E-BE04-48F4-9292-9007BD76C8A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29603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E3C411-4DBC-4709-8476-A4BCA249FD7D}" type="datetimeFigureOut">
              <a:rPr lang="en-GB" smtClean="0"/>
              <a:pPr/>
              <a:t>16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02402E-BE04-48F4-9292-9007BD76C8A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8576963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771900" y="1025691"/>
            <a:ext cx="4232880" cy="3725609"/>
            <a:chOff x="2438400" y="1212697"/>
            <a:chExt cx="4232880" cy="3725609"/>
          </a:xfrm>
        </p:grpSpPr>
        <p:sp>
          <p:nvSpPr>
            <p:cNvPr id="11" name="TextBox 10"/>
            <p:cNvSpPr txBox="1"/>
            <p:nvPr/>
          </p:nvSpPr>
          <p:spPr>
            <a:xfrm>
              <a:off x="5467350" y="3026068"/>
              <a:ext cx="1203930" cy="5131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err="1" smtClean="0"/>
                <a:t>Bcl</a:t>
              </a:r>
              <a:r>
                <a:rPr lang="en-GB" sz="1200" b="1" dirty="0" smtClean="0"/>
                <a:t> – Xl </a:t>
              </a:r>
            </a:p>
            <a:p>
              <a:r>
                <a:rPr lang="en-GB" sz="1200" b="1" dirty="0" smtClean="0"/>
                <a:t>22 </a:t>
              </a:r>
              <a:r>
                <a:rPr lang="en-GB" sz="1200" b="1" dirty="0" err="1" smtClean="0"/>
                <a:t>kDa</a:t>
              </a:r>
              <a:endParaRPr lang="en-GB" sz="1200" b="1" dirty="0"/>
            </a:p>
          </p:txBody>
        </p:sp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38400" y="1212697"/>
              <a:ext cx="3028950" cy="37256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14" name="Group 13"/>
            <p:cNvGrpSpPr/>
            <p:nvPr/>
          </p:nvGrpSpPr>
          <p:grpSpPr>
            <a:xfrm>
              <a:off x="3203360" y="2546391"/>
              <a:ext cx="2207553" cy="652188"/>
              <a:chOff x="3278768" y="2214240"/>
              <a:chExt cx="2608766" cy="586745"/>
            </a:xfrm>
          </p:grpSpPr>
          <p:sp>
            <p:nvSpPr>
              <p:cNvPr id="2" name="TextBox 1"/>
              <p:cNvSpPr txBox="1"/>
              <p:nvPr/>
            </p:nvSpPr>
            <p:spPr>
              <a:xfrm>
                <a:off x="3278768" y="2551781"/>
                <a:ext cx="564893" cy="2492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/>
                  <a:t>      C</a:t>
                </a:r>
                <a:endParaRPr lang="en-GB" sz="1200" b="1" dirty="0"/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3746710" y="2546730"/>
                <a:ext cx="835589" cy="2492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 smtClean="0"/>
                  <a:t>   10nM</a:t>
                </a:r>
                <a:endParaRPr lang="en-GB" sz="1200" b="1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4196869" y="2549064"/>
                <a:ext cx="1087732" cy="2492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/>
                  <a:t>       100 nM</a:t>
                </a:r>
                <a:endParaRPr lang="en-GB" sz="1200" b="1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4958403" y="2549064"/>
                <a:ext cx="929131" cy="2492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 smtClean="0"/>
                  <a:t>       1 µM</a:t>
                </a:r>
                <a:endParaRPr lang="en-GB" sz="1200" b="1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4057388" y="2214240"/>
                <a:ext cx="84510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/>
                  <a:t>Deguelin</a:t>
                </a:r>
                <a:endParaRPr lang="en-GB" sz="1400" b="1" dirty="0"/>
              </a:p>
            </p:txBody>
          </p:sp>
        </p:grpSp>
      </p:grpSp>
      <p:sp>
        <p:nvSpPr>
          <p:cNvPr id="4" name="TextBox 3"/>
          <p:cNvSpPr txBox="1"/>
          <p:nvPr/>
        </p:nvSpPr>
        <p:spPr>
          <a:xfrm>
            <a:off x="4935293" y="552450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Bcl</a:t>
            </a:r>
            <a:r>
              <a:rPr lang="en-US" dirty="0" smtClean="0"/>
              <a:t> -Xl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4780060" y="202095"/>
            <a:ext cx="1056860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Figure A</a:t>
            </a:r>
            <a:endParaRPr lang="ar-SA" dirty="0"/>
          </a:p>
        </p:txBody>
      </p:sp>
    </p:spTree>
    <p:extLst>
      <p:ext uri="{BB962C8B-B14F-4D97-AF65-F5344CB8AC3E}">
        <p14:creationId xmlns:p14="http://schemas.microsoft.com/office/powerpoint/2010/main" xmlns="" val="4107670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367015" y="576066"/>
            <a:ext cx="6035017" cy="5342134"/>
            <a:chOff x="2367015" y="576066"/>
            <a:chExt cx="6035017" cy="5342134"/>
          </a:xfrm>
        </p:grpSpPr>
        <p:sp>
          <p:nvSpPr>
            <p:cNvPr id="5" name="TextBox 4"/>
            <p:cNvSpPr txBox="1"/>
            <p:nvPr/>
          </p:nvSpPr>
          <p:spPr>
            <a:xfrm>
              <a:off x="5371369" y="576066"/>
              <a:ext cx="86069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err="1" smtClean="0"/>
                <a:t>Bax</a:t>
              </a:r>
              <a:endParaRPr lang="en-GB" dirty="0"/>
            </a:p>
          </p:txBody>
        </p:sp>
        <p:grpSp>
          <p:nvGrpSpPr>
            <p:cNvPr id="17" name="Group 16"/>
            <p:cNvGrpSpPr/>
            <p:nvPr/>
          </p:nvGrpSpPr>
          <p:grpSpPr>
            <a:xfrm>
              <a:off x="2367015" y="1094650"/>
              <a:ext cx="6035017" cy="4823550"/>
              <a:chOff x="6348031" y="1615350"/>
              <a:chExt cx="4471190" cy="4236634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>
                <a:off x="7174321" y="1615350"/>
                <a:ext cx="3263776" cy="4236634"/>
              </a:xfrm>
              <a:prstGeom prst="rect">
                <a:avLst/>
              </a:prstGeom>
            </p:spPr>
          </p:pic>
          <p:grpSp>
            <p:nvGrpSpPr>
              <p:cNvPr id="10" name="Group 9"/>
              <p:cNvGrpSpPr/>
              <p:nvPr/>
            </p:nvGrpSpPr>
            <p:grpSpPr>
              <a:xfrm>
                <a:off x="8181095" y="3263872"/>
                <a:ext cx="2638126" cy="718547"/>
                <a:chOff x="2598054" y="3040520"/>
                <a:chExt cx="2638126" cy="718547"/>
              </a:xfrm>
            </p:grpSpPr>
            <p:sp>
              <p:nvSpPr>
                <p:cNvPr id="11" name="TextBox 10"/>
                <p:cNvSpPr txBox="1"/>
                <p:nvPr/>
              </p:nvSpPr>
              <p:spPr>
                <a:xfrm>
                  <a:off x="2598054" y="3463987"/>
                  <a:ext cx="26642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 smtClean="0"/>
                    <a:t>C</a:t>
                  </a:r>
                  <a:endParaRPr lang="en-GB" sz="1200" b="1" dirty="0"/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2924949" y="3482068"/>
                  <a:ext cx="68916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b="1" dirty="0" smtClean="0"/>
                    <a:t>10nM</a:t>
                  </a:r>
                  <a:endParaRPr lang="en-GB" sz="1200" b="1" dirty="0"/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3633467" y="3482068"/>
                  <a:ext cx="67358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 smtClean="0"/>
                    <a:t>100 </a:t>
                  </a:r>
                  <a:r>
                    <a:rPr lang="en-GB" sz="1200" b="1" dirty="0" err="1" smtClean="0"/>
                    <a:t>nM</a:t>
                  </a:r>
                  <a:endParaRPr lang="en-GB" sz="1200" b="1" dirty="0"/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4307049" y="3482068"/>
                  <a:ext cx="92913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b="1" dirty="0" smtClean="0"/>
                    <a:t>1 µM</a:t>
                  </a:r>
                  <a:endParaRPr lang="en-GB" sz="1200" b="1" dirty="0"/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3092566" y="3040520"/>
                  <a:ext cx="84510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b="1" dirty="0" smtClean="0"/>
                    <a:t>Deguelin</a:t>
                  </a:r>
                  <a:endParaRPr lang="en-GB" sz="1400" b="1" dirty="0"/>
                </a:p>
              </p:txBody>
            </p:sp>
          </p:grpSp>
          <p:sp>
            <p:nvSpPr>
              <p:cNvPr id="16" name="TextBox 15"/>
              <p:cNvSpPr txBox="1"/>
              <p:nvPr/>
            </p:nvSpPr>
            <p:spPr>
              <a:xfrm>
                <a:off x="6348031" y="3804844"/>
                <a:ext cx="91602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 err="1" smtClean="0"/>
                  <a:t>Bax</a:t>
                </a:r>
                <a:r>
                  <a:rPr lang="en-GB" sz="1200" b="1" dirty="0" smtClean="0"/>
                  <a:t> </a:t>
                </a:r>
              </a:p>
              <a:p>
                <a:r>
                  <a:rPr lang="en-GB" sz="1200" b="1" dirty="0" smtClean="0"/>
                  <a:t>26 </a:t>
                </a:r>
                <a:r>
                  <a:rPr lang="en-GB" sz="1200" b="1" dirty="0" err="1" smtClean="0"/>
                  <a:t>kDa</a:t>
                </a:r>
                <a:endParaRPr lang="en-GB" sz="1200" b="1" dirty="0"/>
              </a:p>
            </p:txBody>
          </p:sp>
        </p:grpSp>
      </p:grpSp>
      <p:sp>
        <p:nvSpPr>
          <p:cNvPr id="18" name="TextBox 17"/>
          <p:cNvSpPr txBox="1"/>
          <p:nvPr/>
        </p:nvSpPr>
        <p:spPr>
          <a:xfrm>
            <a:off x="5130580" y="198120"/>
            <a:ext cx="1056860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Figure B</a:t>
            </a:r>
            <a:endParaRPr lang="ar-SA" dirty="0"/>
          </a:p>
        </p:txBody>
      </p:sp>
    </p:spTree>
    <p:extLst>
      <p:ext uri="{BB962C8B-B14F-4D97-AF65-F5344CB8AC3E}">
        <p14:creationId xmlns:p14="http://schemas.microsoft.com/office/powerpoint/2010/main" xmlns="" val="40256349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2344670" y="219155"/>
            <a:ext cx="13040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AD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7984836" y="218745"/>
            <a:ext cx="13438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AD</a:t>
            </a:r>
            <a:endParaRPr lang="en-GB" dirty="0"/>
          </a:p>
        </p:txBody>
      </p:sp>
      <p:grpSp>
        <p:nvGrpSpPr>
          <p:cNvPr id="2" name="Group 1"/>
          <p:cNvGrpSpPr/>
          <p:nvPr/>
        </p:nvGrpSpPr>
        <p:grpSpPr>
          <a:xfrm>
            <a:off x="915977" y="604216"/>
            <a:ext cx="4105314" cy="6059220"/>
            <a:chOff x="1571585" y="845086"/>
            <a:chExt cx="4105314" cy="6059220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 flipH="1">
              <a:off x="1571585" y="845086"/>
              <a:ext cx="4105314" cy="6059220"/>
            </a:xfrm>
            <a:prstGeom prst="rect">
              <a:avLst/>
            </a:prstGeom>
          </p:spPr>
        </p:pic>
        <p:grpSp>
          <p:nvGrpSpPr>
            <p:cNvPr id="3" name="Group 2"/>
            <p:cNvGrpSpPr/>
            <p:nvPr/>
          </p:nvGrpSpPr>
          <p:grpSpPr>
            <a:xfrm>
              <a:off x="2702214" y="3326049"/>
              <a:ext cx="2198405" cy="823069"/>
              <a:chOff x="2397414" y="2935998"/>
              <a:chExt cx="2198405" cy="823069"/>
            </a:xfrm>
          </p:grpSpPr>
          <p:sp>
            <p:nvSpPr>
              <p:cNvPr id="9" name="TextBox 8"/>
              <p:cNvSpPr txBox="1"/>
              <p:nvPr/>
            </p:nvSpPr>
            <p:spPr>
              <a:xfrm>
                <a:off x="2397414" y="3482068"/>
                <a:ext cx="2664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/>
                  <a:t>C</a:t>
                </a:r>
                <a:endParaRPr lang="en-GB" sz="1200" b="1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2924949" y="3482068"/>
                <a:ext cx="68916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 smtClean="0"/>
                  <a:t>1µg</a:t>
                </a:r>
                <a:endParaRPr lang="en-GB" sz="1200" b="1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3666688" y="3478286"/>
                <a:ext cx="92913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 smtClean="0"/>
                  <a:t>10 µg</a:t>
                </a:r>
                <a:endParaRPr lang="en-GB" sz="1200" b="1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2924949" y="2935998"/>
                <a:ext cx="84510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/>
                  <a:t>Deguelin</a:t>
                </a:r>
                <a:endParaRPr lang="en-GB" sz="1400" b="1" dirty="0"/>
              </a:p>
            </p:txBody>
          </p:sp>
        </p:grpSp>
      </p:grpSp>
      <p:grpSp>
        <p:nvGrpSpPr>
          <p:cNvPr id="4" name="Group 3"/>
          <p:cNvGrpSpPr/>
          <p:nvPr/>
        </p:nvGrpSpPr>
        <p:grpSpPr>
          <a:xfrm>
            <a:off x="6178995" y="553257"/>
            <a:ext cx="4715162" cy="6110179"/>
            <a:chOff x="6299201" y="761998"/>
            <a:chExt cx="4715162" cy="6110179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6299201" y="761998"/>
              <a:ext cx="4715162" cy="6110179"/>
            </a:xfrm>
            <a:prstGeom prst="rect">
              <a:avLst/>
            </a:prstGeom>
          </p:spPr>
        </p:pic>
        <p:grpSp>
          <p:nvGrpSpPr>
            <p:cNvPr id="17" name="Group 16"/>
            <p:cNvGrpSpPr/>
            <p:nvPr/>
          </p:nvGrpSpPr>
          <p:grpSpPr>
            <a:xfrm>
              <a:off x="7300523" y="3697966"/>
              <a:ext cx="2838766" cy="700060"/>
              <a:chOff x="2397414" y="3065524"/>
              <a:chExt cx="2838766" cy="700060"/>
            </a:xfrm>
          </p:grpSpPr>
          <p:sp>
            <p:nvSpPr>
              <p:cNvPr id="18" name="TextBox 17"/>
              <p:cNvSpPr txBox="1"/>
              <p:nvPr/>
            </p:nvSpPr>
            <p:spPr>
              <a:xfrm>
                <a:off x="2397414" y="3482068"/>
                <a:ext cx="2664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/>
                  <a:t>C</a:t>
                </a:r>
                <a:endParaRPr lang="en-GB" sz="1200" b="1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2884560" y="3488585"/>
                <a:ext cx="68916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 smtClean="0"/>
                  <a:t>1.5 µg</a:t>
                </a:r>
                <a:endParaRPr lang="en-GB" sz="1200" b="1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3633467" y="3482068"/>
                <a:ext cx="4587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/>
                  <a:t>1 µg</a:t>
                </a:r>
                <a:endParaRPr lang="en-GB" sz="1200" b="1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4307049" y="3482068"/>
                <a:ext cx="92913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 smtClean="0"/>
                  <a:t>    1 .5 µg</a:t>
                </a:r>
                <a:endParaRPr lang="en-GB" sz="1200" b="1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2884560" y="3065524"/>
                <a:ext cx="56297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/>
                  <a:t>ERK1</a:t>
                </a:r>
                <a:endParaRPr lang="en-GB" sz="1400" b="1" dirty="0"/>
              </a:p>
            </p:txBody>
          </p:sp>
        </p:grpSp>
        <p:sp>
          <p:nvSpPr>
            <p:cNvPr id="23" name="TextBox 22"/>
            <p:cNvSpPr txBox="1"/>
            <p:nvPr/>
          </p:nvSpPr>
          <p:spPr>
            <a:xfrm>
              <a:off x="8995356" y="3720807"/>
              <a:ext cx="5629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/>
                <a:t>ERK2</a:t>
              </a:r>
              <a:endParaRPr lang="en-GB" sz="1400" b="1" dirty="0"/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7446737" y="2900720"/>
            <a:ext cx="24014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Transfection of ERK 1/2 siRNA</a:t>
            </a:r>
            <a:endParaRPr lang="en-GB" sz="14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4856260" y="0"/>
            <a:ext cx="1056860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Figure C</a:t>
            </a:r>
            <a:endParaRPr lang="ar-SA" dirty="0"/>
          </a:p>
        </p:txBody>
      </p:sp>
    </p:spTree>
    <p:extLst>
      <p:ext uri="{BB962C8B-B14F-4D97-AF65-F5344CB8AC3E}">
        <p14:creationId xmlns:p14="http://schemas.microsoft.com/office/powerpoint/2010/main" xmlns="" val="29503881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2515734" y="576809"/>
            <a:ext cx="3505814" cy="4309974"/>
            <a:chOff x="2515734" y="576809"/>
            <a:chExt cx="3505814" cy="4309974"/>
          </a:xfrm>
        </p:grpSpPr>
        <p:sp>
          <p:nvSpPr>
            <p:cNvPr id="5" name="TextBox 4"/>
            <p:cNvSpPr txBox="1"/>
            <p:nvPr/>
          </p:nvSpPr>
          <p:spPr>
            <a:xfrm>
              <a:off x="3709664" y="576809"/>
              <a:ext cx="18328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Cytochrome C</a:t>
              </a:r>
              <a:endParaRPr lang="en-GB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515734" y="3612369"/>
              <a:ext cx="71490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err="1" smtClean="0"/>
                <a:t>Cyt</a:t>
              </a:r>
              <a:r>
                <a:rPr lang="en-GB" sz="1200" b="1" dirty="0" smtClean="0"/>
                <a:t> C </a:t>
              </a:r>
            </a:p>
            <a:p>
              <a:r>
                <a:rPr lang="en-GB" sz="1200" b="1" dirty="0" smtClean="0"/>
                <a:t>12 </a:t>
              </a:r>
              <a:r>
                <a:rPr lang="en-GB" sz="1200" b="1" dirty="0" err="1" smtClean="0"/>
                <a:t>kDa</a:t>
              </a:r>
              <a:endParaRPr lang="en-GB" sz="1200" b="1" dirty="0"/>
            </a:p>
          </p:txBody>
        </p:sp>
        <p:pic>
          <p:nvPicPr>
            <p:cNvPr id="17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30637" y="1137215"/>
              <a:ext cx="2790911" cy="374956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TextBox 6"/>
            <p:cNvSpPr txBox="1"/>
            <p:nvPr/>
          </p:nvSpPr>
          <p:spPr>
            <a:xfrm>
              <a:off x="5747014" y="3396927"/>
              <a:ext cx="244273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/>
                <a:t>                        </a:t>
              </a:r>
              <a:r>
                <a:rPr lang="en-GB" sz="1000" b="1" dirty="0" smtClean="0"/>
                <a:t>C</a:t>
              </a:r>
              <a:endParaRPr lang="en-GB" sz="1000" b="1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191125" y="3396927"/>
              <a:ext cx="55588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/>
                <a:t>           </a:t>
              </a:r>
              <a:r>
                <a:rPr lang="en-GB" sz="1100" b="1" dirty="0" smtClean="0"/>
                <a:t>    </a:t>
              </a:r>
              <a:r>
                <a:rPr lang="en-GB" sz="1200" b="1" dirty="0" smtClean="0"/>
                <a:t>   </a:t>
              </a:r>
              <a:r>
                <a:rPr lang="en-GB" sz="1000" b="1" dirty="0" smtClean="0"/>
                <a:t>10nM</a:t>
              </a:r>
              <a:endParaRPr lang="en-GB" sz="1000" b="1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441826" y="3581593"/>
              <a:ext cx="9379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/>
                <a:t>      </a:t>
              </a:r>
              <a:r>
                <a:rPr lang="en-GB" sz="1000" b="1" dirty="0" smtClean="0"/>
                <a:t>100 </a:t>
              </a:r>
              <a:r>
                <a:rPr lang="en-GB" sz="1000" b="1" dirty="0" err="1" smtClean="0"/>
                <a:t>nM</a:t>
              </a:r>
              <a:endParaRPr lang="en-GB" sz="100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188812" y="3596981"/>
              <a:ext cx="6344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  1 µM</a:t>
              </a:r>
              <a:endParaRPr lang="en-GB" sz="10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626092" y="3219766"/>
              <a:ext cx="7537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Deguelin</a:t>
              </a:r>
              <a:endParaRPr lang="en-GB" sz="1200" b="1" dirty="0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3957100" y="217335"/>
            <a:ext cx="1056860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Figure D</a:t>
            </a:r>
            <a:endParaRPr lang="ar-SA" dirty="0"/>
          </a:p>
        </p:txBody>
      </p:sp>
    </p:spTree>
    <p:extLst>
      <p:ext uri="{BB962C8B-B14F-4D97-AF65-F5344CB8AC3E}">
        <p14:creationId xmlns:p14="http://schemas.microsoft.com/office/powerpoint/2010/main" xmlns="" val="30822138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195840" y="1243874"/>
            <a:ext cx="6981667" cy="4961698"/>
            <a:chOff x="1195840" y="1243874"/>
            <a:chExt cx="6981667" cy="4961698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118750" y="1243874"/>
              <a:ext cx="6058757" cy="4961698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2417488" y="3186284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C</a:t>
              </a:r>
              <a:endParaRPr lang="en-GB" sz="120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195840" y="3445374"/>
              <a:ext cx="14134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err="1" smtClean="0"/>
                <a:t>Erk</a:t>
              </a:r>
              <a:r>
                <a:rPr lang="en-GB" sz="1200" b="1" dirty="0" smtClean="0"/>
                <a:t> 1 44 </a:t>
              </a:r>
              <a:r>
                <a:rPr lang="en-GB" sz="1200" b="1" dirty="0" err="1" smtClean="0"/>
                <a:t>KDa</a:t>
              </a:r>
              <a:endParaRPr lang="en-GB" sz="1200" b="1" dirty="0" smtClean="0"/>
            </a:p>
            <a:p>
              <a:r>
                <a:rPr lang="en-GB" sz="1200" b="1" dirty="0" err="1" smtClean="0"/>
                <a:t>Erk</a:t>
              </a:r>
              <a:r>
                <a:rPr lang="en-GB" sz="1200" b="1" dirty="0" smtClean="0"/>
                <a:t> 2 42 </a:t>
              </a:r>
              <a:r>
                <a:rPr lang="en-GB" sz="1200" b="1" dirty="0" err="1" smtClean="0"/>
                <a:t>KDa</a:t>
              </a:r>
              <a:endParaRPr lang="en-GB" sz="120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629859" y="3002337"/>
              <a:ext cx="2863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/>
                <a:t>C</a:t>
              </a:r>
              <a:endParaRPr lang="en-GB" sz="12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132429" y="3002337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1 µg</a:t>
              </a:r>
              <a:endParaRPr lang="en-GB" sz="120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807391" y="3007772"/>
              <a:ext cx="642205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/>
                <a:t>1.5 µg</a:t>
              </a:r>
              <a:endParaRPr lang="en-GB" sz="120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773053" y="2592943"/>
              <a:ext cx="22331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/>
                <a:t>Transfection of ERK 2 siRNA</a:t>
              </a:r>
              <a:endParaRPr lang="en-GB" sz="1400" b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7516125" y="2995327"/>
              <a:ext cx="642205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/>
                <a:t>2 µg</a:t>
              </a:r>
              <a:endParaRPr lang="en-GB" sz="1200" b="1" dirty="0"/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2776348" y="2567999"/>
            <a:ext cx="22331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Transfection of ERK </a:t>
            </a:r>
            <a:r>
              <a:rPr lang="en-GB" sz="1400" b="1" dirty="0"/>
              <a:t>1</a:t>
            </a:r>
            <a:r>
              <a:rPr lang="en-GB" sz="1400" b="1" dirty="0" smtClean="0"/>
              <a:t> siRNA</a:t>
            </a:r>
            <a:endParaRPr lang="en-GB" sz="14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2932029" y="3168375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1 µg</a:t>
            </a:r>
            <a:endParaRPr lang="en-GB" sz="12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3464116" y="3168376"/>
            <a:ext cx="642205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1.5 µg</a:t>
            </a:r>
            <a:endParaRPr lang="en-GB" sz="12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4182375" y="3133826"/>
            <a:ext cx="642205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2 µg</a:t>
            </a:r>
            <a:endParaRPr lang="en-GB" sz="12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8177507" y="3053937"/>
            <a:ext cx="14134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err="1" smtClean="0"/>
              <a:t>Erk</a:t>
            </a:r>
            <a:r>
              <a:rPr lang="en-GB" sz="1200" b="1" dirty="0" smtClean="0"/>
              <a:t> 1 44 </a:t>
            </a:r>
            <a:r>
              <a:rPr lang="en-GB" sz="1200" b="1" dirty="0" err="1" smtClean="0"/>
              <a:t>KDa</a:t>
            </a:r>
            <a:endParaRPr lang="en-GB" sz="1200" b="1" dirty="0" smtClean="0"/>
          </a:p>
          <a:p>
            <a:r>
              <a:rPr lang="en-GB" sz="1200" b="1" dirty="0" err="1" smtClean="0"/>
              <a:t>Erk</a:t>
            </a:r>
            <a:r>
              <a:rPr lang="en-GB" sz="1200" b="1" dirty="0" smtClean="0"/>
              <a:t> 2 42 </a:t>
            </a:r>
            <a:r>
              <a:rPr lang="en-GB" sz="1200" b="1" dirty="0" err="1" smtClean="0"/>
              <a:t>KDa</a:t>
            </a:r>
            <a:endParaRPr lang="en-GB" sz="12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4503477" y="819150"/>
            <a:ext cx="9188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RK 1/2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4444780" y="384975"/>
            <a:ext cx="1056860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Figure E</a:t>
            </a:r>
            <a:endParaRPr lang="ar-SA" dirty="0"/>
          </a:p>
        </p:txBody>
      </p:sp>
    </p:spTree>
    <p:extLst>
      <p:ext uri="{BB962C8B-B14F-4D97-AF65-F5344CB8AC3E}">
        <p14:creationId xmlns:p14="http://schemas.microsoft.com/office/powerpoint/2010/main" xmlns="" val="10534499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6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t="2662"/>
          <a:stretch/>
        </p:blipFill>
        <p:spPr bwMode="auto">
          <a:xfrm>
            <a:off x="3376610" y="1657350"/>
            <a:ext cx="2105023" cy="31345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4038600" y="1259443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 smtClean="0"/>
              <a:t>Β</a:t>
            </a:r>
            <a:r>
              <a:rPr lang="en-US" dirty="0" smtClean="0"/>
              <a:t>-actin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3987580" y="887895"/>
            <a:ext cx="1056860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mtClean="0"/>
              <a:t>Figure F</a:t>
            </a:r>
            <a:endParaRPr lang="ar-SA" dirty="0"/>
          </a:p>
        </p:txBody>
      </p:sp>
    </p:spTree>
    <p:extLst>
      <p:ext uri="{BB962C8B-B14F-4D97-AF65-F5344CB8AC3E}">
        <p14:creationId xmlns:p14="http://schemas.microsoft.com/office/powerpoint/2010/main" xmlns="" val="2919268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4</TotalTime>
  <Words>127</Words>
  <Application>Microsoft Office PowerPoint</Application>
  <PresentationFormat>Custom</PresentationFormat>
  <Paragraphs>59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Slide 1</vt:lpstr>
      <vt:lpstr>Slide 2</vt:lpstr>
      <vt:lpstr>Slide 3</vt:lpstr>
      <vt:lpstr>Slide 4</vt:lpstr>
      <vt:lpstr>Slide 5</vt:lpstr>
      <vt:lpstr>Slide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Natesan Pushparaj</dc:creator>
  <cp:lastModifiedBy>00059418</cp:lastModifiedBy>
  <cp:revision>55</cp:revision>
  <cp:lastPrinted>2015-11-28T13:03:56Z</cp:lastPrinted>
  <dcterms:created xsi:type="dcterms:W3CDTF">2015-11-25T19:37:09Z</dcterms:created>
  <dcterms:modified xsi:type="dcterms:W3CDTF">2015-12-16T11:07:39Z</dcterms:modified>
</cp:coreProperties>
</file>